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6"/>
  </p:notesMasterIdLst>
  <p:sldIdLst>
    <p:sldId id="256" r:id="rId5"/>
  </p:sldIdLst>
  <p:sldSz cx="30279975" cy="428069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F058A3F-BEE6-4699-9AEF-F5397B2E347C}" v="14" dt="2020-09-29T16:53:57.30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33"/>
    <p:restoredTop sz="96405"/>
  </p:normalViewPr>
  <p:slideViewPr>
    <p:cSldViewPr snapToGrid="0" snapToObjects="1">
      <p:cViewPr>
        <p:scale>
          <a:sx n="60" d="100"/>
          <a:sy n="60" d="100"/>
        </p:scale>
        <p:origin x="48" y="-30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aleria Ellena" userId="S::valeria.ellena@tuwien.ac.at::73786261-3aa9-40dc-9bad-498b2b95428c" providerId="AD" clId="Web-{9F058A3F-BEE6-4699-9AEF-F5397B2E347C}"/>
    <pc:docChg chg="modSld">
      <pc:chgData name="Valeria Ellena" userId="S::valeria.ellena@tuwien.ac.at::73786261-3aa9-40dc-9bad-498b2b95428c" providerId="AD" clId="Web-{9F058A3F-BEE6-4699-9AEF-F5397B2E347C}" dt="2020-09-29T16:53:57.301" v="13" actId="20577"/>
      <pc:docMkLst>
        <pc:docMk/>
      </pc:docMkLst>
      <pc:sldChg chg="modSp">
        <pc:chgData name="Valeria Ellena" userId="S::valeria.ellena@tuwien.ac.at::73786261-3aa9-40dc-9bad-498b2b95428c" providerId="AD" clId="Web-{9F058A3F-BEE6-4699-9AEF-F5397B2E347C}" dt="2020-09-29T16:53:57.301" v="12" actId="20577"/>
        <pc:sldMkLst>
          <pc:docMk/>
          <pc:sldMk cId="1921551277" sldId="256"/>
        </pc:sldMkLst>
        <pc:spChg chg="mod">
          <ac:chgData name="Valeria Ellena" userId="S::valeria.ellena@tuwien.ac.at::73786261-3aa9-40dc-9bad-498b2b95428c" providerId="AD" clId="Web-{9F058A3F-BEE6-4699-9AEF-F5397B2E347C}" dt="2020-09-29T16:53:57.301" v="12" actId="20577"/>
          <ac:spMkLst>
            <pc:docMk/>
            <pc:sldMk cId="1921551277" sldId="256"/>
            <ac:spMk id="19" creationId="{B9655D07-A82F-064A-9D2F-87DA110C3D5D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249372-EFCC-0B49-B90D-FB8C84F14948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6800" y="1143000"/>
            <a:ext cx="2184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A72368-37F3-2849-98BF-6930E6B2579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299203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A72368-37F3-2849-98BF-6930E6B2579E}" type="slidenum">
              <a:rPr lang="en-AT" smtClean="0"/>
              <a:t>1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1792426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998" y="7005676"/>
            <a:ext cx="25737979" cy="14903156"/>
          </a:xfrm>
        </p:spPr>
        <p:txBody>
          <a:bodyPr anchor="b"/>
          <a:lstStyle>
            <a:lvl1pPr algn="ctr">
              <a:defRPr sz="1986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4997" y="22483555"/>
            <a:ext cx="22709981" cy="10335098"/>
          </a:xfrm>
        </p:spPr>
        <p:txBody>
          <a:bodyPr/>
          <a:lstStyle>
            <a:lvl1pPr marL="0" indent="0" algn="ctr">
              <a:buNone/>
              <a:defRPr sz="7948"/>
            </a:lvl1pPr>
            <a:lvl2pPr marL="1514018" indent="0" algn="ctr">
              <a:buNone/>
              <a:defRPr sz="6623"/>
            </a:lvl2pPr>
            <a:lvl3pPr marL="3028036" indent="0" algn="ctr">
              <a:buNone/>
              <a:defRPr sz="5961"/>
            </a:lvl3pPr>
            <a:lvl4pPr marL="4542053" indent="0" algn="ctr">
              <a:buNone/>
              <a:defRPr sz="5298"/>
            </a:lvl4pPr>
            <a:lvl5pPr marL="6056071" indent="0" algn="ctr">
              <a:buNone/>
              <a:defRPr sz="5298"/>
            </a:lvl5pPr>
            <a:lvl6pPr marL="7570089" indent="0" algn="ctr">
              <a:buNone/>
              <a:defRPr sz="5298"/>
            </a:lvl6pPr>
            <a:lvl7pPr marL="9084107" indent="0" algn="ctr">
              <a:buNone/>
              <a:defRPr sz="5298"/>
            </a:lvl7pPr>
            <a:lvl8pPr marL="10598125" indent="0" algn="ctr">
              <a:buNone/>
              <a:defRPr sz="5298"/>
            </a:lvl8pPr>
            <a:lvl9pPr marL="12112142" indent="0" algn="ctr">
              <a:buNone/>
              <a:defRPr sz="5298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6331419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111390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9109" y="2279073"/>
            <a:ext cx="6529120" cy="3627690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1750" y="2279073"/>
            <a:ext cx="19208859" cy="3627690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937343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500643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979" y="10672020"/>
            <a:ext cx="26116478" cy="17806494"/>
          </a:xfrm>
        </p:spPr>
        <p:txBody>
          <a:bodyPr anchor="b"/>
          <a:lstStyle>
            <a:lvl1pPr>
              <a:defRPr sz="19869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979" y="28646970"/>
            <a:ext cx="26116478" cy="9364015"/>
          </a:xfrm>
        </p:spPr>
        <p:txBody>
          <a:bodyPr/>
          <a:lstStyle>
            <a:lvl1pPr marL="0" indent="0">
              <a:buNone/>
              <a:defRPr sz="7948">
                <a:solidFill>
                  <a:schemeClr val="tx1"/>
                </a:solidFill>
              </a:defRPr>
            </a:lvl1pPr>
            <a:lvl2pPr marL="1514018" indent="0">
              <a:buNone/>
              <a:defRPr sz="6623">
                <a:solidFill>
                  <a:schemeClr val="tx1">
                    <a:tint val="75000"/>
                  </a:schemeClr>
                </a:solidFill>
              </a:defRPr>
            </a:lvl2pPr>
            <a:lvl3pPr marL="3028036" indent="0">
              <a:buNone/>
              <a:defRPr sz="5961">
                <a:solidFill>
                  <a:schemeClr val="tx1">
                    <a:tint val="75000"/>
                  </a:schemeClr>
                </a:solidFill>
              </a:defRPr>
            </a:lvl3pPr>
            <a:lvl4pPr marL="4542053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4pPr>
            <a:lvl5pPr marL="6056071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5pPr>
            <a:lvl6pPr marL="7570089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6pPr>
            <a:lvl7pPr marL="9084107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7pPr>
            <a:lvl8pPr marL="10598125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8pPr>
            <a:lvl9pPr marL="12112142" indent="0">
              <a:buNone/>
              <a:defRPr sz="529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191763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1748" y="11395365"/>
            <a:ext cx="12868989" cy="2716060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9238" y="11395365"/>
            <a:ext cx="12868989" cy="2716060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4548398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692" y="2279083"/>
            <a:ext cx="26116478" cy="8274029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5695" y="10493648"/>
            <a:ext cx="12809847" cy="5142775"/>
          </a:xfrm>
        </p:spPr>
        <p:txBody>
          <a:bodyPr anchor="b"/>
          <a:lstStyle>
            <a:lvl1pPr marL="0" indent="0">
              <a:buNone/>
              <a:defRPr sz="7948" b="1"/>
            </a:lvl1pPr>
            <a:lvl2pPr marL="1514018" indent="0">
              <a:buNone/>
              <a:defRPr sz="6623" b="1"/>
            </a:lvl2pPr>
            <a:lvl3pPr marL="3028036" indent="0">
              <a:buNone/>
              <a:defRPr sz="5961" b="1"/>
            </a:lvl3pPr>
            <a:lvl4pPr marL="4542053" indent="0">
              <a:buNone/>
              <a:defRPr sz="5298" b="1"/>
            </a:lvl4pPr>
            <a:lvl5pPr marL="6056071" indent="0">
              <a:buNone/>
              <a:defRPr sz="5298" b="1"/>
            </a:lvl5pPr>
            <a:lvl6pPr marL="7570089" indent="0">
              <a:buNone/>
              <a:defRPr sz="5298" b="1"/>
            </a:lvl6pPr>
            <a:lvl7pPr marL="9084107" indent="0">
              <a:buNone/>
              <a:defRPr sz="5298" b="1"/>
            </a:lvl7pPr>
            <a:lvl8pPr marL="10598125" indent="0">
              <a:buNone/>
              <a:defRPr sz="5298" b="1"/>
            </a:lvl8pPr>
            <a:lvl9pPr marL="12112142" indent="0">
              <a:buNone/>
              <a:defRPr sz="5298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5695" y="15636423"/>
            <a:ext cx="12809847" cy="2299882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9239" y="10493648"/>
            <a:ext cx="12872933" cy="5142775"/>
          </a:xfrm>
        </p:spPr>
        <p:txBody>
          <a:bodyPr anchor="b"/>
          <a:lstStyle>
            <a:lvl1pPr marL="0" indent="0">
              <a:buNone/>
              <a:defRPr sz="7948" b="1"/>
            </a:lvl1pPr>
            <a:lvl2pPr marL="1514018" indent="0">
              <a:buNone/>
              <a:defRPr sz="6623" b="1"/>
            </a:lvl2pPr>
            <a:lvl3pPr marL="3028036" indent="0">
              <a:buNone/>
              <a:defRPr sz="5961" b="1"/>
            </a:lvl3pPr>
            <a:lvl4pPr marL="4542053" indent="0">
              <a:buNone/>
              <a:defRPr sz="5298" b="1"/>
            </a:lvl4pPr>
            <a:lvl5pPr marL="6056071" indent="0">
              <a:buNone/>
              <a:defRPr sz="5298" b="1"/>
            </a:lvl5pPr>
            <a:lvl6pPr marL="7570089" indent="0">
              <a:buNone/>
              <a:defRPr sz="5298" b="1"/>
            </a:lvl6pPr>
            <a:lvl7pPr marL="9084107" indent="0">
              <a:buNone/>
              <a:defRPr sz="5298" b="1"/>
            </a:lvl7pPr>
            <a:lvl8pPr marL="10598125" indent="0">
              <a:buNone/>
              <a:defRPr sz="5298" b="1"/>
            </a:lvl8pPr>
            <a:lvl9pPr marL="12112142" indent="0">
              <a:buNone/>
              <a:defRPr sz="5298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9239" y="15636423"/>
            <a:ext cx="12872933" cy="2299882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0424808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784596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658845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692" y="2853796"/>
            <a:ext cx="9766080" cy="9988286"/>
          </a:xfrm>
        </p:spPr>
        <p:txBody>
          <a:bodyPr anchor="b"/>
          <a:lstStyle>
            <a:lvl1pPr>
              <a:defRPr sz="1059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72933" y="6163416"/>
            <a:ext cx="15329237" cy="30420671"/>
          </a:xfrm>
        </p:spPr>
        <p:txBody>
          <a:bodyPr/>
          <a:lstStyle>
            <a:lvl1pPr>
              <a:defRPr sz="10597"/>
            </a:lvl1pPr>
            <a:lvl2pPr>
              <a:defRPr sz="9272"/>
            </a:lvl2pPr>
            <a:lvl3pPr>
              <a:defRPr sz="7948"/>
            </a:lvl3pPr>
            <a:lvl4pPr>
              <a:defRPr sz="6623"/>
            </a:lvl4pPr>
            <a:lvl5pPr>
              <a:defRPr sz="6623"/>
            </a:lvl5pPr>
            <a:lvl6pPr>
              <a:defRPr sz="6623"/>
            </a:lvl6pPr>
            <a:lvl7pPr>
              <a:defRPr sz="6623"/>
            </a:lvl7pPr>
            <a:lvl8pPr>
              <a:defRPr sz="6623"/>
            </a:lvl8pPr>
            <a:lvl9pPr>
              <a:defRPr sz="6623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692" y="12842082"/>
            <a:ext cx="9766080" cy="23791544"/>
          </a:xfrm>
        </p:spPr>
        <p:txBody>
          <a:bodyPr/>
          <a:lstStyle>
            <a:lvl1pPr marL="0" indent="0">
              <a:buNone/>
              <a:defRPr sz="5298"/>
            </a:lvl1pPr>
            <a:lvl2pPr marL="1514018" indent="0">
              <a:buNone/>
              <a:defRPr sz="4636"/>
            </a:lvl2pPr>
            <a:lvl3pPr marL="3028036" indent="0">
              <a:buNone/>
              <a:defRPr sz="3974"/>
            </a:lvl3pPr>
            <a:lvl4pPr marL="4542053" indent="0">
              <a:buNone/>
              <a:defRPr sz="3312"/>
            </a:lvl4pPr>
            <a:lvl5pPr marL="6056071" indent="0">
              <a:buNone/>
              <a:defRPr sz="3312"/>
            </a:lvl5pPr>
            <a:lvl6pPr marL="7570089" indent="0">
              <a:buNone/>
              <a:defRPr sz="3312"/>
            </a:lvl6pPr>
            <a:lvl7pPr marL="9084107" indent="0">
              <a:buNone/>
              <a:defRPr sz="3312"/>
            </a:lvl7pPr>
            <a:lvl8pPr marL="10598125" indent="0">
              <a:buNone/>
              <a:defRPr sz="3312"/>
            </a:lvl8pPr>
            <a:lvl9pPr marL="12112142" indent="0">
              <a:buNone/>
              <a:defRPr sz="3312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560760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5692" y="2853796"/>
            <a:ext cx="9766080" cy="9988286"/>
          </a:xfrm>
        </p:spPr>
        <p:txBody>
          <a:bodyPr anchor="b"/>
          <a:lstStyle>
            <a:lvl1pPr>
              <a:defRPr sz="10597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72933" y="6163416"/>
            <a:ext cx="15329237" cy="30420671"/>
          </a:xfrm>
        </p:spPr>
        <p:txBody>
          <a:bodyPr anchor="t"/>
          <a:lstStyle>
            <a:lvl1pPr marL="0" indent="0">
              <a:buNone/>
              <a:defRPr sz="10597"/>
            </a:lvl1pPr>
            <a:lvl2pPr marL="1514018" indent="0">
              <a:buNone/>
              <a:defRPr sz="9272"/>
            </a:lvl2pPr>
            <a:lvl3pPr marL="3028036" indent="0">
              <a:buNone/>
              <a:defRPr sz="7948"/>
            </a:lvl3pPr>
            <a:lvl4pPr marL="4542053" indent="0">
              <a:buNone/>
              <a:defRPr sz="6623"/>
            </a:lvl4pPr>
            <a:lvl5pPr marL="6056071" indent="0">
              <a:buNone/>
              <a:defRPr sz="6623"/>
            </a:lvl5pPr>
            <a:lvl6pPr marL="7570089" indent="0">
              <a:buNone/>
              <a:defRPr sz="6623"/>
            </a:lvl6pPr>
            <a:lvl7pPr marL="9084107" indent="0">
              <a:buNone/>
              <a:defRPr sz="6623"/>
            </a:lvl7pPr>
            <a:lvl8pPr marL="10598125" indent="0">
              <a:buNone/>
              <a:defRPr sz="6623"/>
            </a:lvl8pPr>
            <a:lvl9pPr marL="12112142" indent="0">
              <a:buNone/>
              <a:defRPr sz="6623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5692" y="12842082"/>
            <a:ext cx="9766080" cy="23791544"/>
          </a:xfrm>
        </p:spPr>
        <p:txBody>
          <a:bodyPr/>
          <a:lstStyle>
            <a:lvl1pPr marL="0" indent="0">
              <a:buNone/>
              <a:defRPr sz="5298"/>
            </a:lvl1pPr>
            <a:lvl2pPr marL="1514018" indent="0">
              <a:buNone/>
              <a:defRPr sz="4636"/>
            </a:lvl2pPr>
            <a:lvl3pPr marL="3028036" indent="0">
              <a:buNone/>
              <a:defRPr sz="3974"/>
            </a:lvl3pPr>
            <a:lvl4pPr marL="4542053" indent="0">
              <a:buNone/>
              <a:defRPr sz="3312"/>
            </a:lvl4pPr>
            <a:lvl5pPr marL="6056071" indent="0">
              <a:buNone/>
              <a:defRPr sz="3312"/>
            </a:lvl5pPr>
            <a:lvl6pPr marL="7570089" indent="0">
              <a:buNone/>
              <a:defRPr sz="3312"/>
            </a:lvl6pPr>
            <a:lvl7pPr marL="9084107" indent="0">
              <a:buNone/>
              <a:defRPr sz="3312"/>
            </a:lvl7pPr>
            <a:lvl8pPr marL="10598125" indent="0">
              <a:buNone/>
              <a:defRPr sz="3312"/>
            </a:lvl8pPr>
            <a:lvl9pPr marL="12112142" indent="0">
              <a:buNone/>
              <a:defRPr sz="3312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8403050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1749" y="2279083"/>
            <a:ext cx="26116478" cy="82740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1749" y="11395365"/>
            <a:ext cx="26116478" cy="2716060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1748" y="39675699"/>
            <a:ext cx="6812994" cy="22790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A27B5E-D019-E443-A621-2CDBD252381F}" type="datetimeFigureOut">
              <a:rPr lang="en-AT" smtClean="0"/>
              <a:t>09/29/2020</a:t>
            </a:fld>
            <a:endParaRPr lang="en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30242" y="39675699"/>
            <a:ext cx="10219492" cy="22790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85233" y="39675699"/>
            <a:ext cx="6812994" cy="227907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E3C0B9-FFE4-8C43-997D-679D0A9945DE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49328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8036" rtl="0" eaLnBrk="1" latinLnBrk="0" hangingPunct="1">
        <a:lnSpc>
          <a:spcPct val="90000"/>
        </a:lnSpc>
        <a:spcBef>
          <a:spcPct val="0"/>
        </a:spcBef>
        <a:buNone/>
        <a:defRPr sz="1457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7009" indent="-757009" algn="l" defTabSz="3028036" rtl="0" eaLnBrk="1" latinLnBrk="0" hangingPunct="1">
        <a:lnSpc>
          <a:spcPct val="90000"/>
        </a:lnSpc>
        <a:spcBef>
          <a:spcPts val="3312"/>
        </a:spcBef>
        <a:buFont typeface="Arial" panose="020B0604020202020204" pitchFamily="34" charset="0"/>
        <a:buChar char="•"/>
        <a:defRPr sz="9272" kern="1200">
          <a:solidFill>
            <a:schemeClr val="tx1"/>
          </a:solidFill>
          <a:latin typeface="+mn-lt"/>
          <a:ea typeface="+mn-ea"/>
          <a:cs typeface="+mn-cs"/>
        </a:defRPr>
      </a:lvl1pPr>
      <a:lvl2pPr marL="2271027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7948" kern="1200">
          <a:solidFill>
            <a:schemeClr val="tx1"/>
          </a:solidFill>
          <a:latin typeface="+mn-lt"/>
          <a:ea typeface="+mn-ea"/>
          <a:cs typeface="+mn-cs"/>
        </a:defRPr>
      </a:lvl2pPr>
      <a:lvl3pPr marL="3785045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6623" kern="1200">
          <a:solidFill>
            <a:schemeClr val="tx1"/>
          </a:solidFill>
          <a:latin typeface="+mn-lt"/>
          <a:ea typeface="+mn-ea"/>
          <a:cs typeface="+mn-cs"/>
        </a:defRPr>
      </a:lvl3pPr>
      <a:lvl4pPr marL="5299062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4pPr>
      <a:lvl5pPr marL="6813080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5pPr>
      <a:lvl6pPr marL="8327098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6pPr>
      <a:lvl7pPr marL="9841116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7pPr>
      <a:lvl8pPr marL="11355134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8pPr>
      <a:lvl9pPr marL="12869151" indent="-757009" algn="l" defTabSz="3028036" rtl="0" eaLnBrk="1" latinLnBrk="0" hangingPunct="1">
        <a:lnSpc>
          <a:spcPct val="90000"/>
        </a:lnSpc>
        <a:spcBef>
          <a:spcPts val="1656"/>
        </a:spcBef>
        <a:buFont typeface="Arial" panose="020B0604020202020204" pitchFamily="34" charset="0"/>
        <a:buChar char="•"/>
        <a:defRPr sz="596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1pPr>
      <a:lvl2pPr marL="1514018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2pPr>
      <a:lvl3pPr marL="3028036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3pPr>
      <a:lvl4pPr marL="4542053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4pPr>
      <a:lvl5pPr marL="6056071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5pPr>
      <a:lvl6pPr marL="7570089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6pPr>
      <a:lvl7pPr marL="9084107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7pPr>
      <a:lvl8pPr marL="10598125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8pPr>
      <a:lvl9pPr marL="12112142" algn="l" defTabSz="3028036" rtl="0" eaLnBrk="1" latinLnBrk="0" hangingPunct="1">
        <a:defRPr sz="596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F23A8ED-1CC2-8841-999D-F503A2FB1B5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6298" y="25049923"/>
            <a:ext cx="28446408" cy="1304400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2844CA7-AAF3-F147-89EA-AAE3C530023B}"/>
              </a:ext>
            </a:extLst>
          </p:cNvPr>
          <p:cNvSpPr txBox="1"/>
          <p:nvPr/>
        </p:nvSpPr>
        <p:spPr>
          <a:xfrm>
            <a:off x="997267" y="589816"/>
            <a:ext cx="28285440" cy="41857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3600"/>
              </a:spcAft>
            </a:pPr>
            <a:r>
              <a:rPr lang="en-AT" sz="8800" dirty="0">
                <a:latin typeface="Avenir Book" panose="02000503020000020003" pitchFamily="2" charset="0"/>
              </a:rPr>
              <a:t>Fungal reproduction – asexual and sexual cycle in members of the genus </a:t>
            </a:r>
            <a:r>
              <a:rPr lang="en-AT" sz="8800" i="1" dirty="0">
                <a:latin typeface="Avenir Book" panose="02000503020000020003" pitchFamily="2" charset="0"/>
              </a:rPr>
              <a:t>Aspergillus</a:t>
            </a:r>
            <a:endParaRPr lang="en-AT" sz="8800" dirty="0">
              <a:latin typeface="Avenir Book" panose="02000503020000020003" pitchFamily="2" charset="0"/>
            </a:endParaRPr>
          </a:p>
          <a:p>
            <a:pPr algn="ctr"/>
            <a:r>
              <a:rPr lang="en-AT" sz="6000" dirty="0">
                <a:latin typeface="Avenir Book" panose="02000503020000020003" pitchFamily="2" charset="0"/>
              </a:rPr>
              <a:t>Valeria Ellena, Michael Sauer and Matthias G. Steig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89B8A21-04AF-1949-B492-DCCCAFC5F2A3}"/>
              </a:ext>
            </a:extLst>
          </p:cNvPr>
          <p:cNvSpPr txBox="1"/>
          <p:nvPr/>
        </p:nvSpPr>
        <p:spPr>
          <a:xfrm>
            <a:off x="997267" y="5097221"/>
            <a:ext cx="28446411" cy="17322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6500"/>
              </a:lnSpc>
            </a:pPr>
            <a:r>
              <a:rPr lang="en-AT" sz="48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The fungal genus of the aspergilli (</a:t>
            </a:r>
            <a:r>
              <a:rPr lang="en-AT" sz="48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Aspergillus</a:t>
            </a:r>
            <a:r>
              <a:rPr lang="en-AT" sz="48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 sp.) provides a good opportunity to study reproduction in fungi because it includes species reproducing asexually and sexually</a:t>
            </a:r>
            <a:r>
              <a:rPr lang="en-AT" sz="48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1</a:t>
            </a:r>
            <a:r>
              <a:rPr lang="en-AT" sz="48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A57E81B-D1FF-6E45-92B3-4CCB7779CCEE}"/>
              </a:ext>
            </a:extLst>
          </p:cNvPr>
          <p:cNvSpPr txBox="1"/>
          <p:nvPr/>
        </p:nvSpPr>
        <p:spPr>
          <a:xfrm>
            <a:off x="990015" y="37789618"/>
            <a:ext cx="14147554" cy="455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AT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1) Dyer P. S., </a:t>
            </a:r>
            <a:r>
              <a:rPr lang="en-AT" sz="29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Sex in Fungi </a:t>
            </a:r>
            <a:r>
              <a:rPr lang="en-AT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(2007): 123-142.</a:t>
            </a:r>
          </a:p>
          <a:p>
            <a:pPr algn="just"/>
            <a:r>
              <a:rPr lang="en-AT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2) </a:t>
            </a:r>
            <a:r>
              <a:rPr lang="en-GB" sz="29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Krijgsheld</a:t>
            </a:r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 P. et al., </a:t>
            </a:r>
            <a:r>
              <a:rPr lang="en-GB" sz="29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Studies in Mycology </a:t>
            </a:r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74 (2013): 1-29.</a:t>
            </a:r>
          </a:p>
          <a:p>
            <a:pPr algn="just"/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3) </a:t>
            </a:r>
            <a:r>
              <a:rPr lang="en-GB" sz="29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Varga</a:t>
            </a:r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 J. et al., </a:t>
            </a:r>
            <a:r>
              <a:rPr lang="en-GB" sz="2900" i="1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Mycopathologia</a:t>
            </a:r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 178.5-6 (2014): 349-362.</a:t>
            </a:r>
          </a:p>
          <a:p>
            <a:pPr algn="just"/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4) Lee S. C. et al., </a:t>
            </a:r>
            <a:r>
              <a:rPr lang="en-GB" sz="29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Microbiology and Molecular Biology Reviews </a:t>
            </a:r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74.2 (2010): 298-340.</a:t>
            </a:r>
          </a:p>
          <a:p>
            <a:pPr algn="just"/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5) </a:t>
            </a:r>
            <a:r>
              <a:rPr lang="en-GB" sz="2900" dirty="0" err="1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Nieuwenhuis</a:t>
            </a:r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 B. P. S. and James T. Y., </a:t>
            </a:r>
            <a:r>
              <a:rPr lang="en-GB" sz="29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Philosophical Transactions of the Royal Society B: Biological Sciences </a:t>
            </a:r>
            <a:r>
              <a:rPr lang="en-GB" sz="29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371.1706 (2016): 20150540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6) Dyer P. S., and </a:t>
            </a:r>
            <a:r>
              <a:rPr lang="en-GB" sz="2900" dirty="0" err="1">
                <a:solidFill>
                  <a:srgbClr val="222222"/>
                </a:solidFill>
                <a:latin typeface="Avenir Light" panose="020B0402020203020204" pitchFamily="34" charset="77"/>
              </a:rPr>
              <a:t>Kück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 U., </a:t>
            </a:r>
            <a:r>
              <a:rPr lang="en-GB" sz="2900" i="1" dirty="0">
                <a:solidFill>
                  <a:srgbClr val="222222"/>
                </a:solidFill>
                <a:latin typeface="Avenir Light" panose="020B0402020203020204" pitchFamily="34" charset="77"/>
              </a:rPr>
              <a:t>The Fungal Kingdom 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(2017): 193-214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7) </a:t>
            </a:r>
            <a:r>
              <a:rPr lang="en-GB" sz="2900" dirty="0" err="1">
                <a:solidFill>
                  <a:srgbClr val="222222"/>
                </a:solidFill>
                <a:latin typeface="Avenir Light" panose="020B0402020203020204" pitchFamily="34" charset="77"/>
              </a:rPr>
              <a:t>Debuchy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 R. and Turgeon B. G., </a:t>
            </a:r>
            <a:r>
              <a:rPr lang="en-GB" sz="2900" i="1" dirty="0">
                <a:solidFill>
                  <a:srgbClr val="222222"/>
                </a:solidFill>
                <a:latin typeface="Avenir Light" panose="020B0402020203020204" pitchFamily="34" charset="77"/>
              </a:rPr>
              <a:t>Growth, differentiation and sexuality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. Springer, Berlin, Heidelberg, 2006. 293-323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8) Todd R. B. et al. </a:t>
            </a:r>
            <a:r>
              <a:rPr lang="en-GB" sz="2900" i="1" dirty="0">
                <a:solidFill>
                  <a:srgbClr val="222222"/>
                </a:solidFill>
                <a:latin typeface="Avenir Light" panose="020B0402020203020204" pitchFamily="34" charset="77"/>
              </a:rPr>
              <a:t>Nature Protocols </a:t>
            </a:r>
            <a:r>
              <a:rPr lang="en-AT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2.4 (2007): 811</a:t>
            </a:r>
            <a:endParaRPr lang="en-GB" sz="2900" dirty="0">
              <a:solidFill>
                <a:srgbClr val="222222"/>
              </a:solidFill>
              <a:latin typeface="Avenir Light" panose="020B0402020203020204" pitchFamily="34" charset="77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453C022-84C7-2B41-A1F6-11FCC03E0F6D}"/>
              </a:ext>
            </a:extLst>
          </p:cNvPr>
          <p:cNvSpPr txBox="1"/>
          <p:nvPr/>
        </p:nvSpPr>
        <p:spPr>
          <a:xfrm>
            <a:off x="997268" y="7109196"/>
            <a:ext cx="13680000" cy="126922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500"/>
              </a:lnSpc>
              <a:spcAft>
                <a:spcPts val="1200"/>
              </a:spcAft>
            </a:pPr>
            <a:r>
              <a:rPr lang="en-AT" sz="6000" dirty="0">
                <a:solidFill>
                  <a:srgbClr val="00B0F0"/>
                </a:solidFill>
                <a:latin typeface="Avenir Light" panose="020B0402020203020204" pitchFamily="34" charset="77"/>
              </a:rPr>
              <a:t>Asexual cycle</a:t>
            </a:r>
          </a:p>
          <a:p>
            <a:pPr marL="685800" indent="-685800" algn="just">
              <a:lnSpc>
                <a:spcPts val="6500"/>
              </a:lnSpc>
              <a:buClr>
                <a:srgbClr val="00B0F0"/>
              </a:buClr>
              <a:buFont typeface="Arial" panose="020B0604020202020204" pitchFamily="34" charset="0"/>
              <a:buChar char="•"/>
            </a:pPr>
            <a:r>
              <a:rPr lang="en-GB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D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uring asexual development a specialized aerial hypha called conidiophore differentiates from the vegetative mycelium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2,3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00B0F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Asexual spores called conidia and derived from mitosis are formed by the conidiophore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2,3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00B0F0"/>
              </a:buClr>
              <a:buFont typeface="Arial" panose="020B0604020202020204" pitchFamily="34" charset="0"/>
              <a:buChar char="•"/>
            </a:pPr>
            <a:r>
              <a:rPr lang="en-GB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C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onidia are produced fast and abundantly, without the need of a mating partner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2,3,4,5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00B0F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Conidia are released in the environment where they germinate and give rise to a new organism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2,3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00B0F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This process is associated with low costs and allows to maintain the whole genetic pool of the parental strain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4,5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00B0F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The progeny obtained through the asexual cycle consists of individuals identical to the parental strain. Therefore, deleterious mutations can be accumulated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2,3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9655D07-A82F-064A-9D2F-87DA110C3D5D}"/>
              </a:ext>
            </a:extLst>
          </p:cNvPr>
          <p:cNvSpPr txBox="1"/>
          <p:nvPr/>
        </p:nvSpPr>
        <p:spPr>
          <a:xfrm>
            <a:off x="15763677" y="37789619"/>
            <a:ext cx="13680000" cy="410881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9) Dyer P. S. and O'Gorman C. M., </a:t>
            </a:r>
            <a:r>
              <a:rPr lang="en-GB" sz="2900" i="1" dirty="0">
                <a:solidFill>
                  <a:srgbClr val="222222"/>
                </a:solidFill>
                <a:latin typeface="Avenir Light" panose="020B0402020203020204" pitchFamily="34" charset="77"/>
              </a:rPr>
              <a:t>FEMS Microbiology Reviews 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36.1 (2012): 165-192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10) </a:t>
            </a:r>
            <a:r>
              <a:rPr lang="en-GB" sz="2900" dirty="0" err="1">
                <a:solidFill>
                  <a:srgbClr val="222222"/>
                </a:solidFill>
                <a:latin typeface="Avenir Light" panose="020B0402020203020204" pitchFamily="34" charset="77"/>
              </a:rPr>
              <a:t>Kück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 U. and </a:t>
            </a:r>
            <a:r>
              <a:rPr lang="en-GB" sz="2900" dirty="0" err="1">
                <a:solidFill>
                  <a:srgbClr val="222222"/>
                </a:solidFill>
                <a:latin typeface="Avenir Light" panose="020B0402020203020204" pitchFamily="34" charset="77"/>
              </a:rPr>
              <a:t>Böhm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 J., </a:t>
            </a:r>
            <a:r>
              <a:rPr lang="en-GB" sz="2900" i="1" dirty="0">
                <a:solidFill>
                  <a:srgbClr val="222222"/>
                </a:solidFill>
                <a:latin typeface="Avenir Light" panose="020B0402020203020204" pitchFamily="34" charset="77"/>
              </a:rPr>
              <a:t>Applied Microbiology and Biotechnology 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97.22 (2013): 9609-9620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11) Horn B. W. et al., </a:t>
            </a:r>
            <a:r>
              <a:rPr lang="en-GB" sz="2900" i="1" dirty="0" err="1">
                <a:solidFill>
                  <a:srgbClr val="222222"/>
                </a:solidFill>
                <a:latin typeface="Avenir Light" panose="020B0402020203020204" pitchFamily="34" charset="77"/>
              </a:rPr>
              <a:t>Mycologia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 101.3 (2009): 423-429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12) Horn B. W. et al., </a:t>
            </a:r>
            <a:r>
              <a:rPr lang="en-GB" sz="2900" i="1" dirty="0" err="1">
                <a:solidFill>
                  <a:srgbClr val="222222"/>
                </a:solidFill>
                <a:latin typeface="Avenir Light" panose="020B0402020203020204" pitchFamily="34" charset="77"/>
              </a:rPr>
              <a:t>Mycologia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 101.2 (2009): 275-280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13) </a:t>
            </a:r>
            <a:r>
              <a:rPr lang="en-GB" sz="2900" dirty="0" err="1">
                <a:solidFill>
                  <a:srgbClr val="222222"/>
                </a:solidFill>
                <a:latin typeface="Avenir Light" panose="020B0402020203020204" pitchFamily="34" charset="77"/>
              </a:rPr>
              <a:t>Arabatzis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 M. and </a:t>
            </a:r>
            <a:r>
              <a:rPr lang="en-GB" sz="2900" dirty="0" err="1">
                <a:solidFill>
                  <a:srgbClr val="222222"/>
                </a:solidFill>
                <a:latin typeface="Avenir Light" panose="020B0402020203020204" pitchFamily="34" charset="77"/>
              </a:rPr>
              <a:t>Aristea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 V., </a:t>
            </a:r>
            <a:r>
              <a:rPr lang="en-GB" sz="2900" i="1" dirty="0" err="1">
                <a:solidFill>
                  <a:srgbClr val="222222"/>
                </a:solidFill>
                <a:latin typeface="Avenir Light" panose="020B0402020203020204" pitchFamily="34" charset="77"/>
              </a:rPr>
              <a:t>Mycologia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 105.1 (2013): 71-79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14) O’Gorman C. M. et al., </a:t>
            </a:r>
            <a:r>
              <a:rPr lang="en-GB" sz="2900" i="1" dirty="0">
                <a:solidFill>
                  <a:srgbClr val="222222"/>
                </a:solidFill>
                <a:latin typeface="Avenir Light" panose="020B0402020203020204" pitchFamily="34" charset="77"/>
              </a:rPr>
              <a:t>Nature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 457.7228 (2009): 471-474.</a:t>
            </a:r>
          </a:p>
          <a:p>
            <a:pPr algn="just"/>
            <a:r>
              <a:rPr lang="en-GB" sz="2900">
                <a:solidFill>
                  <a:srgbClr val="222222"/>
                </a:solidFill>
                <a:latin typeface="Avenir Light"/>
              </a:rPr>
              <a:t>15) Horn B. W. et al., </a:t>
            </a:r>
            <a:r>
              <a:rPr lang="en-GB" sz="2900" i="1" err="1">
                <a:solidFill>
                  <a:srgbClr val="222222"/>
                </a:solidFill>
                <a:latin typeface="Avenir Light"/>
              </a:rPr>
              <a:t>Mycologia</a:t>
            </a:r>
            <a:r>
              <a:rPr lang="en-GB" sz="2900" dirty="0">
                <a:solidFill>
                  <a:srgbClr val="222222"/>
                </a:solidFill>
                <a:latin typeface="Avenir Light"/>
              </a:rPr>
              <a:t> 103.1 (2011): 174-183.</a:t>
            </a:r>
          </a:p>
          <a:p>
            <a:pPr algn="just"/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16) Horn B. W. et al., </a:t>
            </a:r>
            <a:r>
              <a:rPr lang="en-GB" sz="2900" i="1" dirty="0" err="1">
                <a:solidFill>
                  <a:srgbClr val="222222"/>
                </a:solidFill>
                <a:latin typeface="Avenir Light" panose="020B0402020203020204" pitchFamily="34" charset="77"/>
              </a:rPr>
              <a:t>Mycologia</a:t>
            </a:r>
            <a:r>
              <a:rPr lang="en-GB" sz="2900" dirty="0">
                <a:solidFill>
                  <a:srgbClr val="222222"/>
                </a:solidFill>
                <a:latin typeface="Avenir Light" panose="020B0402020203020204" pitchFamily="34" charset="77"/>
              </a:rPr>
              <a:t> 105.5 (2013): 1153-1163</a:t>
            </a:r>
            <a:r>
              <a:rPr lang="en-GB" dirty="0"/>
              <a:t>.</a:t>
            </a:r>
            <a:endParaRPr lang="en-GB" sz="2900" dirty="0">
              <a:solidFill>
                <a:srgbClr val="222222"/>
              </a:solidFill>
              <a:latin typeface="Avenir Light" panose="020B0402020203020204" pitchFamily="34" charset="77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25094FE-BD3C-5B44-BA7D-8FC84D20E989}"/>
              </a:ext>
            </a:extLst>
          </p:cNvPr>
          <p:cNvSpPr txBox="1"/>
          <p:nvPr/>
        </p:nvSpPr>
        <p:spPr>
          <a:xfrm>
            <a:off x="997267" y="37064946"/>
            <a:ext cx="336368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48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References:</a:t>
            </a:r>
            <a:endParaRPr lang="en-GB" sz="4800" dirty="0">
              <a:solidFill>
                <a:srgbClr val="222222"/>
              </a:solidFill>
              <a:latin typeface="Avenir Light" panose="020B0402020203020204" pitchFamily="34" charset="77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BA43F29-997F-664C-8733-32446D644FEB}"/>
              </a:ext>
            </a:extLst>
          </p:cNvPr>
          <p:cNvSpPr txBox="1"/>
          <p:nvPr/>
        </p:nvSpPr>
        <p:spPr>
          <a:xfrm>
            <a:off x="14677266" y="25901030"/>
            <a:ext cx="146054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AT" sz="36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Figure: Overview of asexual and sexual development in the aspergilli</a:t>
            </a:r>
            <a:r>
              <a:rPr lang="en-AT" sz="3600" i="1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4,8</a:t>
            </a:r>
            <a:r>
              <a:rPr lang="en-AT" sz="36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748E70-EF89-E84A-A592-AF8DD0559FE3}"/>
              </a:ext>
            </a:extLst>
          </p:cNvPr>
          <p:cNvSpPr txBox="1"/>
          <p:nvPr/>
        </p:nvSpPr>
        <p:spPr>
          <a:xfrm>
            <a:off x="15763678" y="7109196"/>
            <a:ext cx="13680001" cy="176936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6500"/>
              </a:lnSpc>
              <a:spcAft>
                <a:spcPts val="1200"/>
              </a:spcAft>
            </a:pPr>
            <a:r>
              <a:rPr lang="en-AT" sz="6000" dirty="0">
                <a:solidFill>
                  <a:srgbClr val="7030A0"/>
                </a:solidFill>
                <a:latin typeface="Avenir Light" panose="020B0402020203020204" pitchFamily="34" charset="77"/>
              </a:rPr>
              <a:t>Sexual cycle</a:t>
            </a:r>
          </a:p>
          <a:p>
            <a:pPr marL="685800" indent="-685800" algn="just">
              <a:lnSpc>
                <a:spcPts val="6500"/>
              </a:lnSpc>
              <a:buClr>
                <a:srgbClr val="7030A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Sexual cycle requires opposite mating-type genes (MAT1-1 and MAT1-2), which regulate the expression of pheromone and pheromone-receptor genes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1,6,7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7030A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The MAT genes can be either present in the same genome (homothallism) or in different genomes (heterothallism)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7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 </a:t>
            </a:r>
          </a:p>
          <a:p>
            <a:pPr marL="685800" indent="-685800" algn="just">
              <a:lnSpc>
                <a:spcPts val="6500"/>
              </a:lnSpc>
              <a:buClr>
                <a:srgbClr val="7030A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Upon hyphal fusion developing sexual structures called cleistothecia are formed, in which crozier cells give rise to the asci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8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7030A0"/>
              </a:buClr>
              <a:buFont typeface="Arial" panose="020B0604020202020204" pitchFamily="34" charset="0"/>
              <a:buChar char="•"/>
            </a:pPr>
            <a:r>
              <a:rPr lang="en-AT" sz="400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Ascospores produced 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by meiosis are formed within the asci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3,8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7030A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This process is associated with high costs (e.g. heterothallic species require a mating partner; only half of the genetic pool of each parent is transmitted to the progeny)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5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7030A0"/>
              </a:buClr>
              <a:buFont typeface="Arial" panose="020B0604020202020204" pitchFamily="34" charset="0"/>
              <a:buChar char="•"/>
            </a:pPr>
            <a:r>
              <a:rPr lang="en-GB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G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enetic recombination derived by meiosis and crossover can provide adaptation to environmental changes and allows to repair genetic damages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6,9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  <a:p>
            <a:pPr marL="685800" indent="-685800" algn="just">
              <a:lnSpc>
                <a:spcPts val="6500"/>
              </a:lnSpc>
              <a:buClr>
                <a:srgbClr val="7030A0"/>
              </a:buClr>
              <a:buFont typeface="Arial" panose="020B0604020202020204" pitchFamily="34" charset="0"/>
              <a:buChar char="•"/>
            </a:pP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A sexual cycle was recently discovered for several aspergilli previously considered asexual (see Table)</a:t>
            </a:r>
            <a:r>
              <a:rPr lang="en-AT" sz="4000" baseline="30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9,10</a:t>
            </a:r>
            <a:r>
              <a:rPr lang="en-AT" sz="4000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.</a:t>
            </a:r>
          </a:p>
        </p:txBody>
      </p:sp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8BFA4A2E-F726-0A4F-BF16-8FFC6C09DF6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99283026"/>
              </p:ext>
            </p:extLst>
          </p:nvPr>
        </p:nvGraphicFramePr>
        <p:xfrm>
          <a:off x="10008074" y="20168567"/>
          <a:ext cx="5363211" cy="5836567"/>
        </p:xfrm>
        <a:graphic>
          <a:graphicData uri="http://schemas.openxmlformats.org/drawingml/2006/table">
            <a:tbl>
              <a:tblPr firstRow="1" bandRow="1">
                <a:tableStyleId>{F2DE63D5-997A-4646-A377-4702673A728D}</a:tableStyleId>
              </a:tblPr>
              <a:tblGrid>
                <a:gridCol w="2851468">
                  <a:extLst>
                    <a:ext uri="{9D8B030D-6E8A-4147-A177-3AD203B41FA5}">
                      <a16:colId xmlns:a16="http://schemas.microsoft.com/office/drawing/2014/main" val="250973610"/>
                    </a:ext>
                  </a:extLst>
                </a:gridCol>
                <a:gridCol w="2511743">
                  <a:extLst>
                    <a:ext uri="{9D8B030D-6E8A-4147-A177-3AD203B41FA5}">
                      <a16:colId xmlns:a16="http://schemas.microsoft.com/office/drawing/2014/main" val="3081793509"/>
                    </a:ext>
                  </a:extLst>
                </a:gridCol>
              </a:tblGrid>
              <a:tr h="624487"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solidFill>
                            <a:schemeClr val="tx1"/>
                          </a:solidFill>
                          <a:latin typeface="Avenir Light" panose="020B0402020203020204" pitchFamily="34" charset="77"/>
                        </a:rPr>
                        <a:t>Species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solidFill>
                            <a:schemeClr val="tx1"/>
                          </a:solidFill>
                          <a:latin typeface="Avenir Light" panose="020B0402020203020204" pitchFamily="34" charset="77"/>
                        </a:rPr>
                        <a:t>Sexual cycle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6144577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flavus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Yes</a:t>
                      </a:r>
                      <a:r>
                        <a:rPr lang="en-AT" sz="3200" b="0" i="0" baseline="30000" dirty="0">
                          <a:latin typeface="Avenir Light" panose="020B0402020203020204" pitchFamily="34" charset="77"/>
                        </a:rPr>
                        <a:t>11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05081690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parasiticus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Yes</a:t>
                      </a:r>
                      <a:r>
                        <a:rPr lang="en-AT" sz="3200" b="0" i="0" baseline="30000" dirty="0">
                          <a:latin typeface="Avenir Light" panose="020B0402020203020204" pitchFamily="34" charset="77"/>
                        </a:rPr>
                        <a:t>12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2308458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terreus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Yes</a:t>
                      </a:r>
                      <a:r>
                        <a:rPr lang="en-AT" sz="3200" b="0" i="0" baseline="30000" dirty="0">
                          <a:latin typeface="Avenir Light" panose="020B0402020203020204" pitchFamily="34" charset="77"/>
                        </a:rPr>
                        <a:t>13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67667805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fumigatus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Yes</a:t>
                      </a:r>
                      <a:r>
                        <a:rPr lang="en-AT" sz="3200" b="0" i="0" baseline="30000" dirty="0">
                          <a:latin typeface="Avenir Light" panose="020B0402020203020204" pitchFamily="34" charset="77"/>
                        </a:rPr>
                        <a:t>14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80295200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nomius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Yes</a:t>
                      </a:r>
                      <a:r>
                        <a:rPr lang="en-AT" sz="3200" b="0" i="0" baseline="30000" dirty="0">
                          <a:latin typeface="Avenir Light" panose="020B0402020203020204" pitchFamily="34" charset="77"/>
                        </a:rPr>
                        <a:t>15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124768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tubingensis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Yes</a:t>
                      </a:r>
                      <a:r>
                        <a:rPr lang="en-AT" sz="3200" b="0" i="0" baseline="30000" dirty="0">
                          <a:latin typeface="Avenir Light" panose="020B0402020203020204" pitchFamily="34" charset="77"/>
                        </a:rPr>
                        <a:t>16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85787874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niger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72667409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oryzae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77416254"/>
                  </a:ext>
                </a:extLst>
              </a:tr>
              <a:tr h="483298">
                <a:tc>
                  <a:txBody>
                    <a:bodyPr/>
                    <a:lstStyle/>
                    <a:p>
                      <a:r>
                        <a:rPr lang="en-AT" sz="3200" b="0" i="1" dirty="0">
                          <a:latin typeface="Avenir Light" panose="020B0402020203020204" pitchFamily="34" charset="77"/>
                        </a:rPr>
                        <a:t>A. sojae</a:t>
                      </a:r>
                    </a:p>
                  </a:txBody>
                  <a:tcPr>
                    <a:lnL w="6350" cap="flat" cmpd="sng" algn="ctr">
                      <a:noFill/>
                      <a:prstDash val="solid"/>
                      <a:miter lim="800000"/>
                    </a:lnL>
                    <a:lnR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AT" sz="3200" b="0" i="0" dirty="0">
                          <a:latin typeface="Avenir Light" panose="020B0402020203020204" pitchFamily="34" charset="77"/>
                        </a:rPr>
                        <a:t>No</a:t>
                      </a:r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miter lim="800000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3518762"/>
                  </a:ext>
                </a:extLst>
              </a:tr>
            </a:tbl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05D9B32C-DDE7-6E4B-982B-2DDBDC205CA9}"/>
              </a:ext>
            </a:extLst>
          </p:cNvPr>
          <p:cNvSpPr txBox="1"/>
          <p:nvPr/>
        </p:nvSpPr>
        <p:spPr>
          <a:xfrm>
            <a:off x="1574801" y="20109521"/>
            <a:ext cx="78900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1200"/>
              </a:spcAft>
            </a:pPr>
            <a:r>
              <a:rPr lang="en-GB" sz="36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T</a:t>
            </a:r>
            <a:r>
              <a:rPr lang="en-AT" sz="36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able: Sexual development was discovered in an increasing number of aspergilli import</a:t>
            </a:r>
            <a:r>
              <a:rPr lang="en-GB" sz="36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an</a:t>
            </a:r>
            <a:r>
              <a:rPr lang="en-AT" sz="3600" i="1" dirty="0">
                <a:solidFill>
                  <a:schemeClr val="tx1">
                    <a:lumMod val="85000"/>
                    <a:lumOff val="15000"/>
                  </a:schemeClr>
                </a:solidFill>
                <a:latin typeface="Avenir Light" panose="020B0402020203020204" pitchFamily="34" charset="77"/>
              </a:rPr>
              <a:t>t to humankind.</a:t>
            </a:r>
          </a:p>
        </p:txBody>
      </p:sp>
    </p:spTree>
    <p:extLst>
      <p:ext uri="{BB962C8B-B14F-4D97-AF65-F5344CB8AC3E}">
        <p14:creationId xmlns:p14="http://schemas.microsoft.com/office/powerpoint/2010/main" val="1921551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38D10E865EBFA341B426400FBB7257D3" ma:contentTypeVersion="4" ma:contentTypeDescription="Ein neues Dokument erstellen." ma:contentTypeScope="" ma:versionID="dc01e571ab0d3a2304d52e689d806610">
  <xsd:schema xmlns:xsd="http://www.w3.org/2001/XMLSchema" xmlns:xs="http://www.w3.org/2001/XMLSchema" xmlns:p="http://schemas.microsoft.com/office/2006/metadata/properties" xmlns:ns2="70178a42-4cf7-4c0e-ab43-02c2b5f6f08b" targetNamespace="http://schemas.microsoft.com/office/2006/metadata/properties" ma:root="true" ma:fieldsID="0d41ae8af69089c9a20b6f9ea3c8925a" ns2:_="">
    <xsd:import namespace="70178a42-4cf7-4c0e-ab43-02c2b5f6f08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0178a42-4cf7-4c0e-ab43-02c2b5f6f08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haltstyp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BB727F5-8AB9-42A1-AA7A-8F39F5D4BF9A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043AF90E-3D1C-421C-A536-3CE1E04B5AD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0693A1FC-738D-41E2-B162-9A84442BCE6F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8</TotalTime>
  <Words>686</Words>
  <Application>Microsoft Office PowerPoint</Application>
  <PresentationFormat>Custom</PresentationFormat>
  <Paragraphs>5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ria Ellena</dc:creator>
  <cp:lastModifiedBy>Valeria Ellena</cp:lastModifiedBy>
  <cp:revision>69</cp:revision>
  <cp:lastPrinted>2020-09-22T09:43:08Z</cp:lastPrinted>
  <dcterms:created xsi:type="dcterms:W3CDTF">2020-07-09T08:52:59Z</dcterms:created>
  <dcterms:modified xsi:type="dcterms:W3CDTF">2020-09-29T16:53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8D10E865EBFA341B426400FBB7257D3</vt:lpwstr>
  </property>
</Properties>
</file>